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880" r:id="rId1"/>
  </p:sldMasterIdLst>
  <p:notesMasterIdLst>
    <p:notesMasterId r:id="rId3"/>
  </p:notesMasterIdLst>
  <p:sldIdLst>
    <p:sldId id="701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50" autoAdjust="0"/>
    <p:restoredTop sz="91741" autoAdjust="0"/>
  </p:normalViewPr>
  <p:slideViewPr>
    <p:cSldViewPr>
      <p:cViewPr varScale="1">
        <p:scale>
          <a:sx n="109" d="100"/>
          <a:sy n="109" d="100"/>
        </p:scale>
        <p:origin x="112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4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1172" y="4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/>
          <a:lstStyle>
            <a:lvl1pPr algn="r">
              <a:defRPr sz="1200"/>
            </a:lvl1pPr>
          </a:lstStyle>
          <a:p>
            <a:fld id="{F9884BB8-75A6-4892-A397-81CAB43664EB}" type="datetimeFigureOut">
              <a:rPr lang="en-US" smtClean="0"/>
              <a:pPr/>
              <a:t>1/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85" tIns="45392" rIns="90785" bIns="4539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368" y="4416516"/>
            <a:ext cx="5607679" cy="4183220"/>
          </a:xfrm>
          <a:prstGeom prst="rect">
            <a:avLst/>
          </a:prstGeom>
        </p:spPr>
        <p:txBody>
          <a:bodyPr vert="horz" lIns="90785" tIns="45392" rIns="90785" bIns="4539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827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1172" y="8829827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 anchor="b"/>
          <a:lstStyle>
            <a:lvl1pPr algn="r">
              <a:defRPr sz="1200"/>
            </a:lvl1pPr>
          </a:lstStyle>
          <a:p>
            <a:fld id="{342107A6-C9D9-48BE-9B38-ADB1D665E1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109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758952"/>
            <a:ext cx="75438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5038" y="4455621"/>
            <a:ext cx="75438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CA3A1-8150-46F8-AB20-5B92F14F2C8C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905744" y="4343400"/>
            <a:ext cx="740664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3888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901AB-05F6-4A6E-81B1-BB9A9D105D28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445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414779"/>
            <a:ext cx="1971675" cy="575742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414779"/>
            <a:ext cx="5800725" cy="5757420"/>
          </a:xfrm>
        </p:spPr>
        <p:txBody>
          <a:bodyPr vert="eaVert" lIns="45720" tIns="0" rIns="45720" bIns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DCD75-C55C-4E4F-B401-E7D10DE84CCB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02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2B0A9-C5B3-4C15-950A-7F3E9276A350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909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960" y="758952"/>
            <a:ext cx="75438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960" y="4453128"/>
            <a:ext cx="75438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B5CCD-3CE3-4B10-B6C6-0C93A1D8BD60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905744" y="4343400"/>
            <a:ext cx="740664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9586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822960" y="286604"/>
            <a:ext cx="7543800" cy="145075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22960" y="1845734"/>
            <a:ext cx="3703320" cy="402336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440" y="1845736"/>
            <a:ext cx="3703320" cy="402335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3B6B5-CAC9-4FED-8C74-8739759061E9}" type="datetime1">
              <a:rPr lang="en-US" smtClean="0"/>
              <a:t>1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106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822960" y="286604"/>
            <a:ext cx="7543800" cy="145075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960" y="1846052"/>
            <a:ext cx="370332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" y="2582334"/>
            <a:ext cx="3703320" cy="328676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440" y="1846052"/>
            <a:ext cx="370332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440" y="2582334"/>
            <a:ext cx="3703320" cy="328676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6BEE2E-F392-4F93-A630-533C16E61A3E}" type="datetime1">
              <a:rPr lang="en-US" smtClean="0"/>
              <a:t>1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900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BFBA6-5223-480F-8B46-EFF53291B2AD}" type="datetime1">
              <a:rPr lang="en-US" smtClean="0"/>
              <a:t>1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399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A636B-C77C-4A72-A28A-CFDE11B1DDF1}" type="datetime1">
              <a:rPr lang="en-US" smtClean="0"/>
              <a:t>1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349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3" y="0"/>
            <a:ext cx="3038093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3030053" y="0"/>
            <a:ext cx="48006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594359"/>
            <a:ext cx="24003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60237" y="731520"/>
            <a:ext cx="5009393" cy="5257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926080"/>
            <a:ext cx="24003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349134" y="6459786"/>
            <a:ext cx="1963883" cy="365125"/>
          </a:xfrm>
        </p:spPr>
        <p:txBody>
          <a:bodyPr/>
          <a:lstStyle>
            <a:lvl1pPr algn="l">
              <a:defRPr/>
            </a:lvl1pPr>
          </a:lstStyle>
          <a:p>
            <a:fld id="{6777F892-C29E-4BFF-A8A6-410D7732884C}" type="datetime1">
              <a:rPr lang="en-US" smtClean="0"/>
              <a:t>1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600450" y="6459786"/>
            <a:ext cx="3486150" cy="365125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9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9141619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2" y="491507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960" y="5074920"/>
            <a:ext cx="7589520" cy="822960"/>
          </a:xfrm>
        </p:spPr>
        <p:txBody>
          <a:bodyPr tIns="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" y="0"/>
            <a:ext cx="9143989" cy="4915076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22959" y="5907024"/>
            <a:ext cx="7589520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EE459-5345-4516-BF24-063034BFA0CC}" type="datetime1">
              <a:rPr lang="en-US" smtClean="0"/>
              <a:t>1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353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6400800"/>
            <a:ext cx="9144001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0" y="6334315"/>
            <a:ext cx="9144001" cy="6599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22960" y="286604"/>
            <a:ext cx="75438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959" y="1845734"/>
            <a:ext cx="7543801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22961" y="6459786"/>
            <a:ext cx="18542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67F0F527-C55C-4F5F-9A68-1E5FA2BEF2DB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64639" y="6459786"/>
            <a:ext cx="36171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cap="all" baseline="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25344" y="6459786"/>
            <a:ext cx="98401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895149" y="1737845"/>
            <a:ext cx="74752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3808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81" r:id="rId1"/>
    <p:sldLayoutId id="2147483882" r:id="rId2"/>
    <p:sldLayoutId id="2147483883" r:id="rId3"/>
    <p:sldLayoutId id="2147483884" r:id="rId4"/>
    <p:sldLayoutId id="2147483885" r:id="rId5"/>
    <p:sldLayoutId id="2147483886" r:id="rId6"/>
    <p:sldLayoutId id="2147483887" r:id="rId7"/>
    <p:sldLayoutId id="2147483888" r:id="rId8"/>
    <p:sldLayoutId id="2147483889" r:id="rId9"/>
    <p:sldLayoutId id="2147483890" r:id="rId10"/>
    <p:sldLayoutId id="2147483891" r:id="rId11"/>
  </p:sldLayoutIdLst>
  <p:hf hd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1</a:t>
            </a:fld>
            <a:endParaRPr lang="en-US"/>
          </a:p>
        </p:txBody>
      </p:sp>
      <p:pic>
        <p:nvPicPr>
          <p:cNvPr id="11" name="Picture 10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86554"/>
            <a:ext cx="3962400" cy="4537846"/>
          </a:xfrm>
          <a:prstGeom prst="rect">
            <a:avLst/>
          </a:prstGeom>
        </p:spPr>
      </p:pic>
      <p:pic>
        <p:nvPicPr>
          <p:cNvPr id="12" name="Picture 11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199" y="186555"/>
            <a:ext cx="3962401" cy="4537846"/>
          </a:xfrm>
          <a:prstGeom prst="rect">
            <a:avLst/>
          </a:prstGeom>
        </p:spPr>
      </p:pic>
      <p:sp>
        <p:nvSpPr>
          <p:cNvPr id="13" name="TextBox 5"/>
          <p:cNvSpPr txBox="1"/>
          <p:nvPr/>
        </p:nvSpPr>
        <p:spPr>
          <a:xfrm>
            <a:off x="228600" y="457200"/>
            <a:ext cx="914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3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3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4" name="TextBox 6"/>
          <p:cNvSpPr txBox="1"/>
          <p:nvPr/>
        </p:nvSpPr>
        <p:spPr>
          <a:xfrm>
            <a:off x="8576945" y="457200"/>
            <a:ext cx="4146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3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3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5181600"/>
            <a:ext cx="8763000" cy="783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</a:t>
            </a:r>
            <a:r>
              <a:rPr lang="en-US" sz="1400" b="1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- Figure S1. </a:t>
            </a: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vival Estimates by Patient age and tumor grade. 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plan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ier survival analysis to estimate overall survival in patients as a function of age (A) or tumor stage (B). Patient survival was displayed visually in Kaplan Meier plots and significance of differences determined with Log Rank test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76909513"/>
      </p:ext>
    </p:extLst>
  </p:cSld>
  <p:clrMapOvr>
    <a:masterClrMapping/>
  </p:clrMapOvr>
</p:sld>
</file>

<file path=ppt/theme/theme1.xml><?xml version="1.0" encoding="utf-8"?>
<a:theme xmlns:a="http://schemas.openxmlformats.org/drawingml/2006/main" name="Retrospect">
  <a:themeElements>
    <a:clrScheme name="Retrospect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34</TotalTime>
  <Words>61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Retrospect</vt:lpstr>
      <vt:lpstr>PowerPoint Presentation</vt:lpstr>
    </vt:vector>
  </TitlesOfParts>
  <Company>L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UHS</dc:creator>
  <cp:lastModifiedBy>Drakes, Maureen</cp:lastModifiedBy>
  <cp:revision>812</cp:revision>
  <cp:lastPrinted>2017-10-10T16:29:47Z</cp:lastPrinted>
  <dcterms:created xsi:type="dcterms:W3CDTF">2011-06-08T22:30:47Z</dcterms:created>
  <dcterms:modified xsi:type="dcterms:W3CDTF">2018-01-05T16:48:45Z</dcterms:modified>
</cp:coreProperties>
</file>